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94"/>
  </p:normalViewPr>
  <p:slideViewPr>
    <p:cSldViewPr snapToGrid="0">
      <p:cViewPr varScale="1">
        <p:scale>
          <a:sx n="120" d="100"/>
          <a:sy n="120" d="100"/>
        </p:scale>
        <p:origin x="208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B4F3A1-4878-5152-4C67-777A6652027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22170ED-3975-E825-2FE8-1F253B5CA7A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CA943C-2F23-24E0-7834-BC09B6B108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49EB38-B136-5D4A-B21A-0AC258492F21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B0962D-3943-C607-1895-36F814F624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6C777E0-E21C-0649-ECA2-5E41780C69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04DFF7-C8E2-1A41-ACDD-9A11ACB6F1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64948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DF01F0-71D7-BAD1-6CA3-8717D06E56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A16A8C7-A284-A3BF-63E8-34D02DCAB52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0F5762-0542-63BE-2E7C-EBD6FD3232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49EB38-B136-5D4A-B21A-0AC258492F21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43D475-773E-CA72-1CA7-FC81AD12FB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B2EA6E-52F6-9A23-9E90-CCC7BA97EA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04DFF7-C8E2-1A41-ACDD-9A11ACB6F1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77976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AF53C02-9351-9B37-DC6E-5C14FF042B3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4DE6BCB-EF21-1551-3923-B4FA883798F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74E032D-CFA7-6A1C-67CB-11500F3D1C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49EB38-B136-5D4A-B21A-0AC258492F21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F1EBFA-6CFF-A7ED-BB4C-B745341A2D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151A66-38CF-2340-DAA3-D9D53D6527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04DFF7-C8E2-1A41-ACDD-9A11ACB6F1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87696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94F73D-D28C-0E62-D00C-04C8017657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962E073-FD1A-017B-AE4F-19EFAD47908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A7ACAD-3B5C-9BEB-D298-3B62C811A9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49EB38-B136-5D4A-B21A-0AC258492F21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B0F358-0A32-BEB2-4DEF-BD3ED036DB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359693-DC19-B5D3-E1D0-24CDF969B9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04DFF7-C8E2-1A41-ACDD-9A11ACB6F1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26401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341F81-C66F-9A25-5E22-223029FFEA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63551DA-4587-CD4E-AA64-F8B90C4639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30D87A-6A42-CF61-63F9-7F626340BB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49EB38-B136-5D4A-B21A-0AC258492F21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1E4888-644D-529D-E2BD-E6EDE51982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C4C8F7-62FF-5237-04C5-A5FD19AD90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04DFF7-C8E2-1A41-ACDD-9A11ACB6F1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74981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2756E3-8C76-4882-04CC-C7ED07A122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69718AE-6302-D93B-01F4-858BD2CA8C1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07259B8-C452-B454-105D-224A7F3BFCE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360AA63-456B-F9FD-835C-3D5088FC96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49EB38-B136-5D4A-B21A-0AC258492F21}" type="datetimeFigureOut">
              <a:rPr lang="en-US" smtClean="0"/>
              <a:t>2/19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B59FBD6-C2D6-5100-0445-604558BB0A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91DED45-98DF-812C-F99B-D54326F62E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04DFF7-C8E2-1A41-ACDD-9A11ACB6F1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43389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5D981C-9937-BCCC-A9B5-B471262361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1AA1EF3-EF6E-1A38-18B7-C73B763E32A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2D6EC04-F637-C2E4-535B-77259EF2807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7754313-B175-F726-91ED-9C9009DA754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1079EFF-5A05-08ED-E6A8-A06E13CC789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05F8B60-5AE1-5BC3-B17E-E9BEF995F4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49EB38-B136-5D4A-B21A-0AC258492F21}" type="datetimeFigureOut">
              <a:rPr lang="en-US" smtClean="0"/>
              <a:t>2/19/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C6F9CB9-5744-E654-0950-DE37433493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A14E360-C7D1-C5B4-F25A-D1B5F3DA11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04DFF7-C8E2-1A41-ACDD-9A11ACB6F1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11081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5FC265-140C-7912-CE32-DB04F81C04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E47490D-0578-7B9E-4A5F-EA6BC35B81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49EB38-B136-5D4A-B21A-0AC258492F21}" type="datetimeFigureOut">
              <a:rPr lang="en-US" smtClean="0"/>
              <a:t>2/19/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E0AB6D5-D25C-E33E-DDD1-1EDF8B1EBD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6AED385-EF36-0252-9E6C-055984DD68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04DFF7-C8E2-1A41-ACDD-9A11ACB6F1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10903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14E719A-EB3C-820E-BB47-2297DFE607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49EB38-B136-5D4A-B21A-0AC258492F21}" type="datetimeFigureOut">
              <a:rPr lang="en-US" smtClean="0"/>
              <a:t>2/19/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216A166-AD0E-62FF-CCF5-67B1B6DB7D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E23344B-EA5B-D3BD-93AF-10FAD67D30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04DFF7-C8E2-1A41-ACDD-9A11ACB6F1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20673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5C6CD5-5CF1-754C-6122-FA8A31AFF0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DB37E28-F11D-7065-C474-8F78F49C087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C2EEEAE-4CEF-ABFB-F45F-EC437A6CEDB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1C29945-40AF-8BB4-B72B-BF9B45F675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49EB38-B136-5D4A-B21A-0AC258492F21}" type="datetimeFigureOut">
              <a:rPr lang="en-US" smtClean="0"/>
              <a:t>2/19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20DBE09-DE5C-76B6-1107-CB5664BF4A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A243A7E-3DE9-406E-71F4-D2C2E31F13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04DFF7-C8E2-1A41-ACDD-9A11ACB6F1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55887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ECC6D7-6C84-D3DF-F974-D9B14C28F3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C082A0E-F40C-29C7-5812-CCAF26A1A4A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0D14CBB-3065-19C3-3FF4-6447546F1B3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D4BA1C8-939A-5356-1437-2B50E8C68C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49EB38-B136-5D4A-B21A-0AC258492F21}" type="datetimeFigureOut">
              <a:rPr lang="en-US" smtClean="0"/>
              <a:t>2/19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68F5DC-B96B-B1F3-E13C-8E1E9FF78E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460E3F6-5D46-837F-E8A0-C84C13FFFC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04DFF7-C8E2-1A41-ACDD-9A11ACB6F1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15187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694A5F9-D7DF-D0A4-33E7-971413745C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4C76A6E-1FEA-80CF-6EC3-18901A9D13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4DA28B-2095-BE02-7BE1-354BFC84206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549EB38-B136-5D4A-B21A-0AC258492F21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2B5E1F-96E1-6BD5-0F83-C84FBB8CB28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F9D4109-4665-DC45-E7A9-99D9629B716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204DFF7-C8E2-1A41-ACDD-9A11ACB6F1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20385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2AD028B8-B50C-6D8D-35F6-2F2D917F940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95600" y="0"/>
            <a:ext cx="6400800" cy="57658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4B4B7286-DBE5-59D5-85D9-13EE1CFC63F9}"/>
              </a:ext>
            </a:extLst>
          </p:cNvPr>
          <p:cNvSpPr txBox="1"/>
          <p:nvPr/>
        </p:nvSpPr>
        <p:spPr>
          <a:xfrm>
            <a:off x="-1772" y="5688449"/>
            <a:ext cx="12193772" cy="11695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 fontAlgn="base">
              <a:buNone/>
            </a:pPr>
            <a:r>
              <a:rPr lang="en-US" sz="14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Figure S5: hFlex3a2_v2 variant </a:t>
            </a:r>
            <a:r>
              <a:rPr lang="en-US" sz="1400" b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IpaD</a:t>
            </a:r>
            <a:r>
              <a:rPr lang="en-US" sz="14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 and </a:t>
            </a:r>
            <a:r>
              <a:rPr lang="en-US" sz="1400" b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polyreactiviy</a:t>
            </a:r>
            <a:r>
              <a:rPr lang="en-US" sz="14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 ELISAs 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(A) An ELISA showing reactivity to </a:t>
            </a:r>
            <a:r>
              <a:rPr lang="en-US" sz="14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IpaD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 that was performed in parallel to the ELISA in Figures 4E and 4F. The Control </a:t>
            </a:r>
            <a:r>
              <a:rPr lang="en-US" sz="14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mAb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 shows binding, as </a:t>
            </a:r>
            <a:r>
              <a:rPr lang="en-US" sz="14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IpaD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 is the known target antigen of this </a:t>
            </a:r>
            <a:r>
              <a:rPr lang="en-US" sz="14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mAb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. This experiment is the result of three replicates performed in duplicate. (B) ELISA measuring non-specific binding of hFlex3a2_v2 variants to 5 </a:t>
            </a:r>
            <a:r>
              <a:rPr lang="en-US" sz="1400" dirty="0">
                <a:solidFill>
                  <a:srgbClr val="000000"/>
                </a:solidFill>
                <a:effectLst/>
                <a:latin typeface="Symbol" pitchFamily="2" charset="2"/>
                <a:ea typeface="Yu Gothic Light" panose="020B0300000000000000" pitchFamily="34" charset="-128"/>
              </a:rPr>
              <a:t>m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g/mL of insulin, CHO-SMPs, or ssDNA. A known poly-reactive </a:t>
            </a:r>
            <a:r>
              <a:rPr lang="en-US" sz="14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mAb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 (4E10 targeting HIV-1) and a known non-polyreactive </a:t>
            </a:r>
            <a:r>
              <a:rPr lang="en-US" sz="14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mAb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 (Adalimumab) serve as positive and negative controls, respectively. This experiment is the result of three replicates. </a:t>
            </a:r>
            <a:endParaRPr lang="en-US" sz="14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912958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3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Symbo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ayden Schmidt</dc:creator>
  <cp:lastModifiedBy>Hayden Schmidt</cp:lastModifiedBy>
  <cp:revision>1</cp:revision>
  <dcterms:created xsi:type="dcterms:W3CDTF">2026-02-19T23:46:06Z</dcterms:created>
  <dcterms:modified xsi:type="dcterms:W3CDTF">2026-02-19T23:46:19Z</dcterms:modified>
</cp:coreProperties>
</file>